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696" y="60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314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7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831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435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160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265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686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940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807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148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04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855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9FD5D425-42F0-4B1C-A56D-C9FE63A7216F}"/>
              </a:ext>
            </a:extLst>
          </p:cNvPr>
          <p:cNvSpPr txBox="1"/>
          <p:nvPr/>
        </p:nvSpPr>
        <p:spPr>
          <a:xfrm>
            <a:off x="732711" y="96892"/>
            <a:ext cx="102705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violin plots reporting the microbial load measured as </a:t>
            </a:r>
            <a:r>
              <a:rPr lang="en-GB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justed mean log</a:t>
            </a:r>
            <a:r>
              <a:rPr lang="en-GB" sz="1400" baseline="-25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GB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16S rRNA copies/µl for each sample type.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s within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olin plots represent median, 25th, and 75th percentile. p &lt; 0.05 is shown as * , p &lt; 0.01 as **, p &lt; 0.001 as ***, and p &lt; 0.0001 as ****.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Oggetto 1">
            <a:extLst>
              <a:ext uri="{FF2B5EF4-FFF2-40B4-BE49-F238E27FC236}">
                <a16:creationId xmlns:a16="http://schemas.microsoft.com/office/drawing/2014/main" id="{74F83880-CEA3-49F4-8139-68C03DF9F3E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1721801"/>
              </p:ext>
            </p:extLst>
          </p:nvPr>
        </p:nvGraphicFramePr>
        <p:xfrm>
          <a:off x="2198688" y="674688"/>
          <a:ext cx="7793037" cy="5508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name="Prism 10" r:id="rId3" imgW="7793697" imgH="5508361" progId="Prism10.Document">
                  <p:embed/>
                </p:oleObj>
              </mc:Choice>
              <mc:Fallback>
                <p:oleObj name="Prism 10" r:id="rId3" imgW="7793697" imgH="5508361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98688" y="674688"/>
                        <a:ext cx="7793037" cy="5508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734206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8</TotalTime>
  <Words>61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GraphPad Prism Project</vt:lpstr>
      <vt:lpstr>Presentazione standard di PowerPoint</vt:lpstr>
    </vt:vector>
  </TitlesOfParts>
  <Company>Università degli Studi di Pado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coni Andrea</dc:creator>
  <cp:lastModifiedBy>Andrea Laconi</cp:lastModifiedBy>
  <cp:revision>20</cp:revision>
  <dcterms:created xsi:type="dcterms:W3CDTF">2022-03-15T12:01:40Z</dcterms:created>
  <dcterms:modified xsi:type="dcterms:W3CDTF">2025-04-17T10:14:42Z</dcterms:modified>
</cp:coreProperties>
</file>